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260" r:id="rId2"/>
  </p:sldIdLst>
  <p:sldSz cx="9251950" cy="7667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RANJAN PRASAD H P" initials="NPHP" lastIdx="1" clrIdx="0"/>
  <p:cmAuthor id="2" name="SUNILKUMAR V P" initials="SVP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62" d="100"/>
          <a:sy n="62" d="100"/>
        </p:scale>
        <p:origin x="150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66863" y="1143000"/>
            <a:ext cx="37242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1pPr>
    <a:lvl2pPr marL="483398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2pPr>
    <a:lvl3pPr marL="966795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3pPr>
    <a:lvl4pPr marL="1450193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4pPr>
    <a:lvl5pPr marL="1933590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5pPr>
    <a:lvl6pPr marL="2416988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6pPr>
    <a:lvl7pPr marL="2900385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7pPr>
    <a:lvl8pPr marL="3383783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8pPr>
    <a:lvl9pPr marL="3867180" algn="l" defTabSz="966795" rtl="0" eaLnBrk="1" latinLnBrk="0" hangingPunct="1">
      <a:defRPr sz="12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66863" y="1143000"/>
            <a:ext cx="37242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rker assisted selection for leaf rust resistance</a:t>
            </a:r>
            <a:r>
              <a:rPr lang="en-US" baseline="0" dirty="0"/>
              <a:t> gene Lr24 among in BC2F2 population</a:t>
            </a:r>
          </a:p>
          <a:p>
            <a:r>
              <a:rPr lang="en-US" baseline="0" dirty="0"/>
              <a:t>Materials: BC2F2 Population HD3086/HI1500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5F339C-994C-43BF-ADA4-8B12FB5FF05A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3896" y="1254864"/>
            <a:ext cx="7864158" cy="2669469"/>
          </a:xfrm>
        </p:spPr>
        <p:txBody>
          <a:bodyPr anchor="b"/>
          <a:lstStyle>
            <a:lvl1pPr algn="ctr">
              <a:defRPr sz="607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6494" y="4027279"/>
            <a:ext cx="6938963" cy="1851234"/>
          </a:xfrm>
        </p:spPr>
        <p:txBody>
          <a:bodyPr/>
          <a:lstStyle>
            <a:lvl1pPr marL="0" indent="0" algn="ctr">
              <a:buNone/>
              <a:defRPr sz="2428"/>
            </a:lvl1pPr>
            <a:lvl2pPr marL="462595" indent="0" algn="ctr">
              <a:buNone/>
              <a:defRPr sz="2024"/>
            </a:lvl2pPr>
            <a:lvl3pPr marL="925190" indent="0" algn="ctr">
              <a:buNone/>
              <a:defRPr sz="1821"/>
            </a:lvl3pPr>
            <a:lvl4pPr marL="1387785" indent="0" algn="ctr">
              <a:buNone/>
              <a:defRPr sz="1619"/>
            </a:lvl4pPr>
            <a:lvl5pPr marL="1850380" indent="0" algn="ctr">
              <a:buNone/>
              <a:defRPr sz="1619"/>
            </a:lvl5pPr>
            <a:lvl6pPr marL="2312975" indent="0" algn="ctr">
              <a:buNone/>
              <a:defRPr sz="1619"/>
            </a:lvl6pPr>
            <a:lvl7pPr marL="2775570" indent="0" algn="ctr">
              <a:buNone/>
              <a:defRPr sz="1619"/>
            </a:lvl7pPr>
            <a:lvl8pPr marL="3238165" indent="0" algn="ctr">
              <a:buNone/>
              <a:defRPr sz="1619"/>
            </a:lvl8pPr>
            <a:lvl9pPr marL="3700760" indent="0" algn="ctr">
              <a:buNone/>
              <a:defRPr sz="161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613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022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0927" y="408230"/>
            <a:ext cx="1994952" cy="64979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36072" y="408230"/>
            <a:ext cx="5869206" cy="649795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208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65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1253" y="1911584"/>
            <a:ext cx="7979807" cy="3189518"/>
          </a:xfrm>
        </p:spPr>
        <p:txBody>
          <a:bodyPr anchor="b"/>
          <a:lstStyle>
            <a:lvl1pPr>
              <a:defRPr sz="607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1253" y="5131276"/>
            <a:ext cx="7979807" cy="1677292"/>
          </a:xfrm>
        </p:spPr>
        <p:txBody>
          <a:bodyPr/>
          <a:lstStyle>
            <a:lvl1pPr marL="0" indent="0">
              <a:buNone/>
              <a:defRPr sz="2428">
                <a:solidFill>
                  <a:schemeClr val="tx1"/>
                </a:solidFill>
              </a:defRPr>
            </a:lvl1pPr>
            <a:lvl2pPr marL="462595" indent="0">
              <a:buNone/>
              <a:defRPr sz="2024">
                <a:solidFill>
                  <a:schemeClr val="tx1">
                    <a:tint val="75000"/>
                  </a:schemeClr>
                </a:solidFill>
              </a:defRPr>
            </a:lvl2pPr>
            <a:lvl3pPr marL="925190" indent="0">
              <a:buNone/>
              <a:defRPr sz="1821">
                <a:solidFill>
                  <a:schemeClr val="tx1">
                    <a:tint val="75000"/>
                  </a:schemeClr>
                </a:solidFill>
              </a:defRPr>
            </a:lvl3pPr>
            <a:lvl4pPr marL="1387785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4pPr>
            <a:lvl5pPr marL="1850380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5pPr>
            <a:lvl6pPr marL="2312975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6pPr>
            <a:lvl7pPr marL="2775570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7pPr>
            <a:lvl8pPr marL="3238165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8pPr>
            <a:lvl9pPr marL="3700760" indent="0">
              <a:buNone/>
              <a:defRPr sz="16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964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6071" y="2041150"/>
            <a:ext cx="3932079" cy="48650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83800" y="2041150"/>
            <a:ext cx="3932079" cy="48650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937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7277" y="408232"/>
            <a:ext cx="7979807" cy="148205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7278" y="1879634"/>
            <a:ext cx="3914008" cy="921179"/>
          </a:xfrm>
        </p:spPr>
        <p:txBody>
          <a:bodyPr anchor="b"/>
          <a:lstStyle>
            <a:lvl1pPr marL="0" indent="0">
              <a:buNone/>
              <a:defRPr sz="2428" b="1"/>
            </a:lvl1pPr>
            <a:lvl2pPr marL="462595" indent="0">
              <a:buNone/>
              <a:defRPr sz="2024" b="1"/>
            </a:lvl2pPr>
            <a:lvl3pPr marL="925190" indent="0">
              <a:buNone/>
              <a:defRPr sz="1821" b="1"/>
            </a:lvl3pPr>
            <a:lvl4pPr marL="1387785" indent="0">
              <a:buNone/>
              <a:defRPr sz="1619" b="1"/>
            </a:lvl4pPr>
            <a:lvl5pPr marL="1850380" indent="0">
              <a:buNone/>
              <a:defRPr sz="1619" b="1"/>
            </a:lvl5pPr>
            <a:lvl6pPr marL="2312975" indent="0">
              <a:buNone/>
              <a:defRPr sz="1619" b="1"/>
            </a:lvl6pPr>
            <a:lvl7pPr marL="2775570" indent="0">
              <a:buNone/>
              <a:defRPr sz="1619" b="1"/>
            </a:lvl7pPr>
            <a:lvl8pPr marL="3238165" indent="0">
              <a:buNone/>
              <a:defRPr sz="1619" b="1"/>
            </a:lvl8pPr>
            <a:lvl9pPr marL="3700760" indent="0">
              <a:buNone/>
              <a:defRPr sz="161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278" y="2800813"/>
            <a:ext cx="3914008" cy="411957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83800" y="1879634"/>
            <a:ext cx="3933284" cy="921179"/>
          </a:xfrm>
        </p:spPr>
        <p:txBody>
          <a:bodyPr anchor="b"/>
          <a:lstStyle>
            <a:lvl1pPr marL="0" indent="0">
              <a:buNone/>
              <a:defRPr sz="2428" b="1"/>
            </a:lvl1pPr>
            <a:lvl2pPr marL="462595" indent="0">
              <a:buNone/>
              <a:defRPr sz="2024" b="1"/>
            </a:lvl2pPr>
            <a:lvl3pPr marL="925190" indent="0">
              <a:buNone/>
              <a:defRPr sz="1821" b="1"/>
            </a:lvl3pPr>
            <a:lvl4pPr marL="1387785" indent="0">
              <a:buNone/>
              <a:defRPr sz="1619" b="1"/>
            </a:lvl4pPr>
            <a:lvl5pPr marL="1850380" indent="0">
              <a:buNone/>
              <a:defRPr sz="1619" b="1"/>
            </a:lvl5pPr>
            <a:lvl6pPr marL="2312975" indent="0">
              <a:buNone/>
              <a:defRPr sz="1619" b="1"/>
            </a:lvl6pPr>
            <a:lvl7pPr marL="2775570" indent="0">
              <a:buNone/>
              <a:defRPr sz="1619" b="1"/>
            </a:lvl7pPr>
            <a:lvl8pPr marL="3238165" indent="0">
              <a:buNone/>
              <a:defRPr sz="1619" b="1"/>
            </a:lvl8pPr>
            <a:lvl9pPr marL="3700760" indent="0">
              <a:buNone/>
              <a:defRPr sz="161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83800" y="2800813"/>
            <a:ext cx="3933284" cy="411957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46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228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973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7276" y="511175"/>
            <a:ext cx="2983995" cy="1789113"/>
          </a:xfrm>
        </p:spPr>
        <p:txBody>
          <a:bodyPr anchor="b"/>
          <a:lstStyle>
            <a:lvl1pPr>
              <a:defRPr sz="323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3284" y="1103997"/>
            <a:ext cx="4683800" cy="5448984"/>
          </a:xfrm>
        </p:spPr>
        <p:txBody>
          <a:bodyPr/>
          <a:lstStyle>
            <a:lvl1pPr>
              <a:defRPr sz="3238"/>
            </a:lvl1pPr>
            <a:lvl2pPr>
              <a:defRPr sz="2833"/>
            </a:lvl2pPr>
            <a:lvl3pPr>
              <a:defRPr sz="2428"/>
            </a:lvl3pPr>
            <a:lvl4pPr>
              <a:defRPr sz="2024"/>
            </a:lvl4pPr>
            <a:lvl5pPr>
              <a:defRPr sz="2024"/>
            </a:lvl5pPr>
            <a:lvl6pPr>
              <a:defRPr sz="2024"/>
            </a:lvl6pPr>
            <a:lvl7pPr>
              <a:defRPr sz="2024"/>
            </a:lvl7pPr>
            <a:lvl8pPr>
              <a:defRPr sz="2024"/>
            </a:lvl8pPr>
            <a:lvl9pPr>
              <a:defRPr sz="202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7276" y="2300288"/>
            <a:ext cx="2983995" cy="4261567"/>
          </a:xfrm>
        </p:spPr>
        <p:txBody>
          <a:bodyPr/>
          <a:lstStyle>
            <a:lvl1pPr marL="0" indent="0">
              <a:buNone/>
              <a:defRPr sz="1619"/>
            </a:lvl1pPr>
            <a:lvl2pPr marL="462595" indent="0">
              <a:buNone/>
              <a:defRPr sz="1417"/>
            </a:lvl2pPr>
            <a:lvl3pPr marL="925190" indent="0">
              <a:buNone/>
              <a:defRPr sz="1214"/>
            </a:lvl3pPr>
            <a:lvl4pPr marL="1387785" indent="0">
              <a:buNone/>
              <a:defRPr sz="1012"/>
            </a:lvl4pPr>
            <a:lvl5pPr marL="1850380" indent="0">
              <a:buNone/>
              <a:defRPr sz="1012"/>
            </a:lvl5pPr>
            <a:lvl6pPr marL="2312975" indent="0">
              <a:buNone/>
              <a:defRPr sz="1012"/>
            </a:lvl6pPr>
            <a:lvl7pPr marL="2775570" indent="0">
              <a:buNone/>
              <a:defRPr sz="1012"/>
            </a:lvl7pPr>
            <a:lvl8pPr marL="3238165" indent="0">
              <a:buNone/>
              <a:defRPr sz="1012"/>
            </a:lvl8pPr>
            <a:lvl9pPr marL="3700760" indent="0">
              <a:buNone/>
              <a:defRPr sz="101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413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7276" y="511175"/>
            <a:ext cx="2983995" cy="1789113"/>
          </a:xfrm>
        </p:spPr>
        <p:txBody>
          <a:bodyPr anchor="b"/>
          <a:lstStyle>
            <a:lvl1pPr>
              <a:defRPr sz="323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33284" y="1103997"/>
            <a:ext cx="4683800" cy="5448984"/>
          </a:xfrm>
        </p:spPr>
        <p:txBody>
          <a:bodyPr anchor="t"/>
          <a:lstStyle>
            <a:lvl1pPr marL="0" indent="0">
              <a:buNone/>
              <a:defRPr sz="3238"/>
            </a:lvl1pPr>
            <a:lvl2pPr marL="462595" indent="0">
              <a:buNone/>
              <a:defRPr sz="2833"/>
            </a:lvl2pPr>
            <a:lvl3pPr marL="925190" indent="0">
              <a:buNone/>
              <a:defRPr sz="2428"/>
            </a:lvl3pPr>
            <a:lvl4pPr marL="1387785" indent="0">
              <a:buNone/>
              <a:defRPr sz="2024"/>
            </a:lvl4pPr>
            <a:lvl5pPr marL="1850380" indent="0">
              <a:buNone/>
              <a:defRPr sz="2024"/>
            </a:lvl5pPr>
            <a:lvl6pPr marL="2312975" indent="0">
              <a:buNone/>
              <a:defRPr sz="2024"/>
            </a:lvl6pPr>
            <a:lvl7pPr marL="2775570" indent="0">
              <a:buNone/>
              <a:defRPr sz="2024"/>
            </a:lvl7pPr>
            <a:lvl8pPr marL="3238165" indent="0">
              <a:buNone/>
              <a:defRPr sz="2024"/>
            </a:lvl8pPr>
            <a:lvl9pPr marL="3700760" indent="0">
              <a:buNone/>
              <a:defRPr sz="202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7276" y="2300288"/>
            <a:ext cx="2983995" cy="4261567"/>
          </a:xfrm>
        </p:spPr>
        <p:txBody>
          <a:bodyPr/>
          <a:lstStyle>
            <a:lvl1pPr marL="0" indent="0">
              <a:buNone/>
              <a:defRPr sz="1619"/>
            </a:lvl1pPr>
            <a:lvl2pPr marL="462595" indent="0">
              <a:buNone/>
              <a:defRPr sz="1417"/>
            </a:lvl2pPr>
            <a:lvl3pPr marL="925190" indent="0">
              <a:buNone/>
              <a:defRPr sz="1214"/>
            </a:lvl3pPr>
            <a:lvl4pPr marL="1387785" indent="0">
              <a:buNone/>
              <a:defRPr sz="1012"/>
            </a:lvl4pPr>
            <a:lvl5pPr marL="1850380" indent="0">
              <a:buNone/>
              <a:defRPr sz="1012"/>
            </a:lvl5pPr>
            <a:lvl6pPr marL="2312975" indent="0">
              <a:buNone/>
              <a:defRPr sz="1012"/>
            </a:lvl6pPr>
            <a:lvl7pPr marL="2775570" indent="0">
              <a:buNone/>
              <a:defRPr sz="1012"/>
            </a:lvl7pPr>
            <a:lvl8pPr marL="3238165" indent="0">
              <a:buNone/>
              <a:defRPr sz="1012"/>
            </a:lvl8pPr>
            <a:lvl9pPr marL="3700760" indent="0">
              <a:buNone/>
              <a:defRPr sz="101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45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6072" y="408232"/>
            <a:ext cx="7979807" cy="148205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6072" y="2041150"/>
            <a:ext cx="7979807" cy="48650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36071" y="7106754"/>
            <a:ext cx="2081689" cy="4082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64709" y="7106754"/>
            <a:ext cx="3122533" cy="4082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34190" y="7106754"/>
            <a:ext cx="2081689" cy="40823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43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25190" rtl="0" eaLnBrk="1" latinLnBrk="0" hangingPunct="1">
        <a:lnSpc>
          <a:spcPct val="90000"/>
        </a:lnSpc>
        <a:spcBef>
          <a:spcPct val="0"/>
        </a:spcBef>
        <a:buNone/>
        <a:defRPr sz="44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1297" indent="-231297" algn="l" defTabSz="925190" rtl="0" eaLnBrk="1" latinLnBrk="0" hangingPunct="1">
        <a:lnSpc>
          <a:spcPct val="90000"/>
        </a:lnSpc>
        <a:spcBef>
          <a:spcPts val="1012"/>
        </a:spcBef>
        <a:buFont typeface="Arial" panose="020B0604020202020204" pitchFamily="34" charset="0"/>
        <a:buChar char="•"/>
        <a:defRPr sz="2833" kern="1200">
          <a:solidFill>
            <a:schemeClr val="tx1"/>
          </a:solidFill>
          <a:latin typeface="+mn-lt"/>
          <a:ea typeface="+mn-ea"/>
          <a:cs typeface="+mn-cs"/>
        </a:defRPr>
      </a:lvl1pPr>
      <a:lvl2pPr marL="693892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2428" kern="1200">
          <a:solidFill>
            <a:schemeClr val="tx1"/>
          </a:solidFill>
          <a:latin typeface="+mn-lt"/>
          <a:ea typeface="+mn-ea"/>
          <a:cs typeface="+mn-cs"/>
        </a:defRPr>
      </a:lvl2pPr>
      <a:lvl3pPr marL="1156487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2024" kern="1200">
          <a:solidFill>
            <a:schemeClr val="tx1"/>
          </a:solidFill>
          <a:latin typeface="+mn-lt"/>
          <a:ea typeface="+mn-ea"/>
          <a:cs typeface="+mn-cs"/>
        </a:defRPr>
      </a:lvl3pPr>
      <a:lvl4pPr marL="1619082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4pPr>
      <a:lvl5pPr marL="2081677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5pPr>
      <a:lvl6pPr marL="2544272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6pPr>
      <a:lvl7pPr marL="3006867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7pPr>
      <a:lvl8pPr marL="3469462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8pPr>
      <a:lvl9pPr marL="3932057" indent="-231297" algn="l" defTabSz="925190" rtl="0" eaLnBrk="1" latinLnBrk="0" hangingPunct="1">
        <a:lnSpc>
          <a:spcPct val="90000"/>
        </a:lnSpc>
        <a:spcBef>
          <a:spcPts val="506"/>
        </a:spcBef>
        <a:buFont typeface="Arial" panose="020B0604020202020204" pitchFamily="34" charset="0"/>
        <a:buChar char="•"/>
        <a:defRPr sz="18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1pPr>
      <a:lvl2pPr marL="462595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2pPr>
      <a:lvl3pPr marL="925190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3pPr>
      <a:lvl4pPr marL="1387785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4pPr>
      <a:lvl5pPr marL="1850380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5pPr>
      <a:lvl6pPr marL="2312975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6pPr>
      <a:lvl7pPr marL="2775570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7pPr>
      <a:lvl8pPr marL="3238165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8pPr>
      <a:lvl9pPr marL="3700760" algn="l" defTabSz="925190" rtl="0" eaLnBrk="1" latinLnBrk="0" hangingPunct="1">
        <a:defRPr sz="18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3" t="4851" r="3538" b="17450"/>
          <a:stretch>
            <a:fillRect/>
          </a:stretch>
        </p:blipFill>
        <p:spPr>
          <a:xfrm>
            <a:off x="556974" y="906841"/>
            <a:ext cx="8393430" cy="2717165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7701565" y="2044910"/>
            <a:ext cx="1197601" cy="233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>
                <a:solidFill>
                  <a:srgbClr val="FFFF00"/>
                </a:solidFill>
              </a:rPr>
              <a:t>Xgwm484</a:t>
            </a:r>
          </a:p>
        </p:txBody>
      </p:sp>
      <p:sp>
        <p:nvSpPr>
          <p:cNvPr id="31" name="TextBox 30"/>
          <p:cNvSpPr txBox="1"/>
          <p:nvPr/>
        </p:nvSpPr>
        <p:spPr>
          <a:xfrm rot="5400000">
            <a:off x="953850" y="1244025"/>
            <a:ext cx="7486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D3086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68374" y="1087419"/>
            <a:ext cx="8369787" cy="669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75" b="1" dirty="0">
                <a:solidFill>
                  <a:srgbClr val="FFFF00"/>
                </a:solidFill>
              </a:rPr>
              <a:t> L                      P</a:t>
            </a:r>
            <a:r>
              <a:rPr lang="en-US" sz="1875" b="1" baseline="-25000" dirty="0">
                <a:solidFill>
                  <a:srgbClr val="FFFF00"/>
                </a:solidFill>
              </a:rPr>
              <a:t>1</a:t>
            </a:r>
            <a:r>
              <a:rPr lang="en-US" sz="1875" b="1" dirty="0">
                <a:solidFill>
                  <a:srgbClr val="FFFF00"/>
                </a:solidFill>
              </a:rPr>
              <a:t>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</a:t>
            </a:r>
            <a:r>
              <a:rPr lang="en-US" sz="1875" b="1" dirty="0">
                <a:solidFill>
                  <a:srgbClr val="FFFF00"/>
                </a:solidFill>
              </a:rPr>
              <a:t>    </a:t>
            </a:r>
          </a:p>
        </p:txBody>
      </p:sp>
      <p:sp>
        <p:nvSpPr>
          <p:cNvPr id="2" name="TextBox 30"/>
          <p:cNvSpPr txBox="1"/>
          <p:nvPr/>
        </p:nvSpPr>
        <p:spPr>
          <a:xfrm rot="5400000">
            <a:off x="1379935" y="1283395"/>
            <a:ext cx="7486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BW43</a:t>
            </a:r>
          </a:p>
        </p:txBody>
      </p:sp>
      <p:sp>
        <p:nvSpPr>
          <p:cNvPr id="4" name="TextBox 28"/>
          <p:cNvSpPr txBox="1"/>
          <p:nvPr/>
        </p:nvSpPr>
        <p:spPr>
          <a:xfrm>
            <a:off x="668374" y="2561890"/>
            <a:ext cx="8369787" cy="380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75" b="1" dirty="0">
                <a:solidFill>
                  <a:srgbClr val="FFFF00"/>
                </a:solidFill>
              </a:rPr>
              <a:t> L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dirty="0">
                <a:solidFill>
                  <a:srgbClr val="FFFF00"/>
                </a:solidFill>
              </a:rPr>
              <a:t>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dirty="0">
                <a:solidFill>
                  <a:srgbClr val="FFFF00"/>
                </a:solidFill>
              </a:rPr>
              <a:t>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dirty="0">
                <a:solidFill>
                  <a:srgbClr val="FFFF00"/>
                </a:solidFill>
              </a:rPr>
              <a:t>     P</a:t>
            </a:r>
            <a:r>
              <a:rPr lang="en-US" sz="1875" b="1" baseline="-25000" dirty="0">
                <a:solidFill>
                  <a:srgbClr val="FFFF00"/>
                </a:solidFill>
              </a:rPr>
              <a:t>1</a:t>
            </a:r>
            <a:r>
              <a:rPr lang="en-US" sz="1875" b="1" dirty="0">
                <a:solidFill>
                  <a:srgbClr val="FFFF00"/>
                </a:solidFill>
              </a:rPr>
              <a:t>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endParaRPr lang="en-US" sz="1875" b="1" dirty="0">
              <a:solidFill>
                <a:srgbClr val="FFFF00"/>
              </a:solidFill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4"/>
          <a:srcRect l="8206" t="12985" r="5864" b="51147"/>
          <a:stretch>
            <a:fillRect/>
          </a:stretch>
        </p:blipFill>
        <p:spPr>
          <a:xfrm>
            <a:off x="556975" y="3653850"/>
            <a:ext cx="8423275" cy="189484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rcRect l="8582" t="10414" r="5372" b="59742"/>
          <a:stretch>
            <a:fillRect/>
          </a:stretch>
        </p:blipFill>
        <p:spPr>
          <a:xfrm>
            <a:off x="556974" y="5578535"/>
            <a:ext cx="8423910" cy="1992630"/>
          </a:xfrm>
          <a:prstGeom prst="rect">
            <a:avLst/>
          </a:prstGeom>
        </p:spPr>
      </p:pic>
      <p:sp>
        <p:nvSpPr>
          <p:cNvPr id="18" name="TextBox 30"/>
          <p:cNvSpPr txBox="1"/>
          <p:nvPr/>
        </p:nvSpPr>
        <p:spPr>
          <a:xfrm rot="5400000">
            <a:off x="953850" y="3860225"/>
            <a:ext cx="7486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D3086</a:t>
            </a:r>
          </a:p>
        </p:txBody>
      </p:sp>
      <p:sp>
        <p:nvSpPr>
          <p:cNvPr id="19" name="TextBox 28"/>
          <p:cNvSpPr txBox="1"/>
          <p:nvPr/>
        </p:nvSpPr>
        <p:spPr>
          <a:xfrm>
            <a:off x="668374" y="3747434"/>
            <a:ext cx="8369787" cy="669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75" b="1" dirty="0">
                <a:solidFill>
                  <a:srgbClr val="FFFF00"/>
                </a:solidFill>
              </a:rPr>
              <a:t> L                     P</a:t>
            </a:r>
            <a:r>
              <a:rPr lang="en-US" sz="1875" b="1" baseline="-25000" dirty="0">
                <a:solidFill>
                  <a:srgbClr val="FFFF00"/>
                </a:solidFill>
              </a:rPr>
              <a:t>1</a:t>
            </a:r>
            <a:r>
              <a:rPr lang="en-US" sz="1875" b="1" dirty="0">
                <a:solidFill>
                  <a:srgbClr val="FFFF00"/>
                </a:solidFill>
              </a:rPr>
              <a:t>    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 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</a:t>
            </a:r>
            <a:r>
              <a:rPr lang="en-US" sz="1875" b="1" dirty="0">
                <a:solidFill>
                  <a:srgbClr val="FFFF00"/>
                </a:solidFill>
              </a:rPr>
              <a:t>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</a:t>
            </a:r>
            <a:r>
              <a:rPr lang="en-US" sz="1875" b="1" dirty="0">
                <a:solidFill>
                  <a:srgbClr val="FFFF00"/>
                </a:solidFill>
              </a:rPr>
              <a:t>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</a:t>
            </a:r>
            <a:endParaRPr lang="en-US" sz="1875" b="1" dirty="0">
              <a:solidFill>
                <a:srgbClr val="FFFF00"/>
              </a:solidFill>
            </a:endParaRPr>
          </a:p>
        </p:txBody>
      </p:sp>
      <p:sp>
        <p:nvSpPr>
          <p:cNvPr id="20" name="TextBox 30"/>
          <p:cNvSpPr txBox="1"/>
          <p:nvPr/>
        </p:nvSpPr>
        <p:spPr>
          <a:xfrm rot="5400000">
            <a:off x="1330404" y="3870385"/>
            <a:ext cx="7289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BW43</a:t>
            </a:r>
          </a:p>
        </p:txBody>
      </p:sp>
      <p:sp>
        <p:nvSpPr>
          <p:cNvPr id="33" name="TextBox 28"/>
          <p:cNvSpPr txBox="1"/>
          <p:nvPr/>
        </p:nvSpPr>
        <p:spPr>
          <a:xfrm>
            <a:off x="808074" y="5740700"/>
            <a:ext cx="8369787" cy="380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75" b="1" dirty="0">
                <a:solidFill>
                  <a:srgbClr val="FFFF00"/>
                </a:solidFill>
              </a:rPr>
              <a:t> L                    P</a:t>
            </a:r>
            <a:r>
              <a:rPr lang="en-US" sz="1875" b="1" baseline="-25000" dirty="0">
                <a:solidFill>
                  <a:srgbClr val="FFFF00"/>
                </a:solidFill>
              </a:rPr>
              <a:t>1</a:t>
            </a:r>
            <a:r>
              <a:rPr lang="en-US" sz="1875" b="1" dirty="0">
                <a:solidFill>
                  <a:srgbClr val="FFFF00"/>
                </a:solidFill>
              </a:rPr>
              <a:t>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1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     H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H     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     </a:t>
            </a:r>
            <a:r>
              <a:rPr lang="en-US" sz="1875" b="1" dirty="0">
                <a:solidFill>
                  <a:srgbClr val="FFFF00"/>
                </a:solidFill>
                <a:sym typeface="+mn-ea"/>
              </a:rPr>
              <a:t>P</a:t>
            </a:r>
            <a:r>
              <a:rPr lang="en-US" sz="1875" b="1" baseline="-25000" dirty="0">
                <a:solidFill>
                  <a:srgbClr val="FFFF00"/>
                </a:solidFill>
                <a:sym typeface="+mn-ea"/>
              </a:rPr>
              <a:t>2</a:t>
            </a:r>
            <a:endParaRPr lang="en-US" sz="1875" b="1" baseline="-25000" dirty="0">
              <a:solidFill>
                <a:srgbClr val="FFFF00"/>
              </a:solidFill>
            </a:endParaRPr>
          </a:p>
        </p:txBody>
      </p:sp>
      <p:sp>
        <p:nvSpPr>
          <p:cNvPr id="34" name="TextBox 30"/>
          <p:cNvSpPr txBox="1"/>
          <p:nvPr/>
        </p:nvSpPr>
        <p:spPr>
          <a:xfrm rot="5400000">
            <a:off x="1044655" y="5896670"/>
            <a:ext cx="7486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D3086</a:t>
            </a:r>
          </a:p>
        </p:txBody>
      </p:sp>
      <p:sp>
        <p:nvSpPr>
          <p:cNvPr id="35" name="TextBox 30"/>
          <p:cNvSpPr txBox="1"/>
          <p:nvPr/>
        </p:nvSpPr>
        <p:spPr>
          <a:xfrm rot="5400000">
            <a:off x="1390094" y="5887145"/>
            <a:ext cx="7289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BW43</a:t>
            </a:r>
          </a:p>
        </p:txBody>
      </p:sp>
      <p:sp>
        <p:nvSpPr>
          <p:cNvPr id="38" name="Rectangle 16"/>
          <p:cNvSpPr/>
          <p:nvPr/>
        </p:nvSpPr>
        <p:spPr>
          <a:xfrm>
            <a:off x="7701565" y="7237305"/>
            <a:ext cx="1197601" cy="233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>
                <a:solidFill>
                  <a:srgbClr val="FFFF00"/>
                </a:solidFill>
              </a:rPr>
              <a:t>Xwmc617</a:t>
            </a:r>
          </a:p>
        </p:txBody>
      </p:sp>
      <p:sp>
        <p:nvSpPr>
          <p:cNvPr id="39" name="Rectangle 16"/>
          <p:cNvSpPr/>
          <p:nvPr/>
        </p:nvSpPr>
        <p:spPr>
          <a:xfrm>
            <a:off x="7701565" y="5207845"/>
            <a:ext cx="1197601" cy="233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i="1" dirty="0">
                <a:solidFill>
                  <a:srgbClr val="FFFF00"/>
                </a:solidFill>
              </a:rPr>
              <a:t>Xwmc64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56974" y="172723"/>
            <a:ext cx="83421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Supplementary Fig 1</a:t>
            </a:r>
            <a:r>
              <a:rPr lang="en-IN" dirty="0"/>
              <a:t>. Gel image of presence of different types bands viz., P1, P2 and H in MABB derived BC2F2 progenies along with their parents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32</Words>
  <Application>Microsoft Office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/>
  <cp:lastModifiedBy>NARAYANA BHAT</cp:lastModifiedBy>
  <cp:revision>6</cp:revision>
  <dcterms:created xsi:type="dcterms:W3CDTF">2023-03-15T11:47:40Z</dcterms:created>
  <dcterms:modified xsi:type="dcterms:W3CDTF">2023-03-23T06:08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F58FAB6C5034E67B3F306A725DE39B1</vt:lpwstr>
  </property>
  <property fmtid="{D5CDD505-2E9C-101B-9397-08002B2CF9AE}" pid="3" name="KSOProductBuildVer">
    <vt:lpwstr>1033-11.2.0.11486</vt:lpwstr>
  </property>
</Properties>
</file>